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29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788389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16459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53802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074154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035198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93883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634780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95921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523781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99445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36492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42D6C-CF49-4986-A614-056EFDAD8BE1}" type="datetimeFigureOut">
              <a:rPr lang="ko-KR" altLang="en-US" smtClean="0"/>
              <a:pPr/>
              <a:t>2017-10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623F1-3BCD-4327-BF3B-4F5C05BF0D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936668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inear 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velocity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 dirty="0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331640" y="1565339"/>
            <a:ext cx="5991225" cy="49911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7437" y="0"/>
            <a:ext cx="2903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3: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dirty="0" err="1" smtClean="0">
                <a:latin typeface="Times New Roman" pitchFamily="18" charset="0"/>
                <a:cs typeface="Times New Roman" pitchFamily="18" charset="0"/>
              </a:rPr>
              <a:t>S3A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236296" y="1988840"/>
            <a:ext cx="1125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1.96 S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6.83</a:t>
            </a:r>
            <a:endParaRPr lang="en-US" altLang="ko-K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246765" y="4808185"/>
            <a:ext cx="1141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96 S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5.25</a:t>
            </a:r>
          </a:p>
        </p:txBody>
      </p:sp>
    </p:spTree>
    <p:extLst>
      <p:ext uri="{BB962C8B-B14F-4D97-AF65-F5344CB8AC3E}">
        <p14:creationId xmlns:p14="http://schemas.microsoft.com/office/powerpoint/2010/main" xmlns="" val="2143103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Angular velocity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직사각형 3"/>
          <p:cNvSpPr/>
          <p:nvPr/>
        </p:nvSpPr>
        <p:spPr>
          <a:xfrm>
            <a:off x="2286000" y="2967335"/>
            <a:ext cx="4572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ko-KR" altLang="en-US" dirty="0"/>
          </a:p>
          <a:p>
            <a:endParaRPr lang="ko-KR" altLang="en-US" dirty="0"/>
          </a:p>
          <a:p>
            <a:endParaRPr lang="ko-KR" altLang="en-US" dirty="0">
              <a:latin typeface="Times New Roman" panose="02020603050405020304" pitchFamily="18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15616" y="1600200"/>
            <a:ext cx="5991225" cy="48006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7437" y="0"/>
            <a:ext cx="29033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Additional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file 3: Figure </a:t>
            </a:r>
            <a:r>
              <a:rPr lang="en-US" altLang="ko-KR" smtClean="0">
                <a:latin typeface="Times New Roman" pitchFamily="18" charset="0"/>
                <a:cs typeface="Times New Roman" pitchFamily="18" charset="0"/>
              </a:rPr>
              <a:t>S3B</a:t>
            </a:r>
            <a:endParaRPr lang="ko-KR" altLang="en-US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20271" y="1988840"/>
            <a:ext cx="11256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1.96 S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3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020271" y="4797152"/>
            <a:ext cx="1141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96 S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5.45</a:t>
            </a:r>
          </a:p>
        </p:txBody>
      </p:sp>
    </p:spTree>
    <p:extLst>
      <p:ext uri="{BB962C8B-B14F-4D97-AF65-F5344CB8AC3E}">
        <p14:creationId xmlns:p14="http://schemas.microsoft.com/office/powerpoint/2010/main" xmlns="" val="3551132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38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테마</vt:lpstr>
      <vt:lpstr>Linear velocity</vt:lpstr>
      <vt:lpstr>Angular velocity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stance</dc:title>
  <dc:creator>samsung</dc:creator>
  <cp:lastModifiedBy>0013439</cp:lastModifiedBy>
  <cp:revision>15</cp:revision>
  <dcterms:created xsi:type="dcterms:W3CDTF">2017-01-01T13:52:16Z</dcterms:created>
  <dcterms:modified xsi:type="dcterms:W3CDTF">2017-10-11T14:39:27Z</dcterms:modified>
</cp:coreProperties>
</file>